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B17C5-7BCA-4245-A0F6-C188B8F541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84213-D949-4C71-98B1-EE3F3C6A70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4F731-3C44-43F1-8B05-BB8E8096E5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297AF-0371-4500-9A34-5EE1C2AA16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5A427-6953-4D15-8BA1-148D5CDB8A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1872E-73EB-42B6-81BC-DDED3EE33F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80DEE-1219-4F16-9FA0-B2C19100DE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EAD47-E53B-4626-9E00-C00A9F1EC2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CB30D-F8F4-4E76-9F35-3438F01794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2DDD4-D5EB-4C3F-809B-0564B8020F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00A71-A8A8-4091-9A1E-58753748C1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688E41-C9BD-4DFD-A3D1-BD92015562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77226D-182E-4AC4-B133-F7429578DAA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2381400" y="3935520"/>
            <a:ext cx="6019560" cy="1684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2381400" y="1874880"/>
            <a:ext cx="4197240" cy="1631880"/>
          </a:xfrm>
          <a:prstGeom prst="rect">
            <a:avLst/>
          </a:prstGeom>
          <a:ln w="0">
            <a:noFill/>
          </a:ln>
        </p:spPr>
      </p:pic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Supplementary Figure 1. Timelines for metabolic and behavioral pilot studies.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3"/>
          <p:cNvSpPr/>
          <p:nvPr/>
        </p:nvSpPr>
        <p:spPr>
          <a:xfrm>
            <a:off x="585720" y="2505240"/>
            <a:ext cx="1589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etabolic pilo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539280" y="4592520"/>
            <a:ext cx="163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ehavioral pilo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5-25T04:49:29Z</dcterms:created>
  <dc:creator>WFBMC</dc:creator>
  <dc:description/>
  <dc:language>en-US</dc:language>
  <cp:lastModifiedBy>Aaron Deal</cp:lastModifiedBy>
  <dcterms:modified xsi:type="dcterms:W3CDTF">2022-03-08T07:52:33Z</dcterms:modified>
  <cp:revision>9</cp:revision>
  <dc:subject/>
  <dc:title>Supp. Table 1 – Sample sizes</dc:title>
</cp:coreProperties>
</file>